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906000" type="A4"/>
  <p:notesSz cx="6794500" cy="99822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3075">
          <p15:clr>
            <a:srgbClr val="A4A3A4"/>
          </p15:clr>
        </p15:guide>
        <p15:guide id="2" pos="2976">
          <p15:clr>
            <a:srgbClr val="A4A3A4"/>
          </p15:clr>
        </p15:guide>
        <p15:guide id="3" orient="horz" pos="1306">
          <p15:clr>
            <a:srgbClr val="A4A3A4"/>
          </p15:clr>
        </p15:guide>
        <p15:guide id="4" pos="572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949" autoAdjust="0"/>
    <p:restoredTop sz="94238" autoAdjust="0"/>
  </p:normalViewPr>
  <p:slideViewPr>
    <p:cSldViewPr>
      <p:cViewPr>
        <p:scale>
          <a:sx n="56" d="100"/>
          <a:sy n="56" d="100"/>
        </p:scale>
        <p:origin x="-2108" y="-52"/>
      </p:cViewPr>
      <p:guideLst>
        <p:guide orient="horz" pos="3075"/>
        <p:guide orient="horz" pos="1306"/>
        <p:guide pos="2976"/>
        <p:guide pos="572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4283" cy="49911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48645" y="0"/>
            <a:ext cx="2944283" cy="49911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4169736-5EA0-4F0C-A671-14FACB21B4DE}" type="datetimeFigureOut">
              <a:rPr lang="en-US" smtClean="0"/>
              <a:t>11/19/2018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101850" y="749300"/>
            <a:ext cx="2590800" cy="37433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450" y="4741545"/>
            <a:ext cx="5435600" cy="449199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81358"/>
            <a:ext cx="2944283" cy="49911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48645" y="9481358"/>
            <a:ext cx="2944283" cy="49911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060EAFD-4791-471C-895E-5F1F35E5661B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83444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060EAFD-4791-471C-895E-5F1F35E5661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37303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A6753-F2AB-41DF-86BF-EB02365846C6}" type="datetimeFigureOut">
              <a:rPr lang="de-DE" smtClean="0"/>
              <a:t>19.11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969DC-3EB3-4B21-9062-8E010B2BB23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21634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A6753-F2AB-41DF-86BF-EB02365846C6}" type="datetimeFigureOut">
              <a:rPr lang="de-DE" smtClean="0"/>
              <a:t>19.11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969DC-3EB3-4B21-9062-8E010B2BB23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652526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A6753-F2AB-41DF-86BF-EB02365846C6}" type="datetimeFigureOut">
              <a:rPr lang="de-DE" smtClean="0"/>
              <a:t>19.11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969DC-3EB3-4B21-9062-8E010B2BB23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148825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A6753-F2AB-41DF-86BF-EB02365846C6}" type="datetimeFigureOut">
              <a:rPr lang="de-DE" smtClean="0"/>
              <a:t>19.11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969DC-3EB3-4B21-9062-8E010B2BB23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115426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A6753-F2AB-41DF-86BF-EB02365846C6}" type="datetimeFigureOut">
              <a:rPr lang="de-DE" smtClean="0"/>
              <a:t>19.11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969DC-3EB3-4B21-9062-8E010B2BB23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199384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A6753-F2AB-41DF-86BF-EB02365846C6}" type="datetimeFigureOut">
              <a:rPr lang="de-DE" smtClean="0"/>
              <a:t>19.11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969DC-3EB3-4B21-9062-8E010B2BB23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539390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A6753-F2AB-41DF-86BF-EB02365846C6}" type="datetimeFigureOut">
              <a:rPr lang="de-DE" smtClean="0"/>
              <a:t>19.11.2018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969DC-3EB3-4B21-9062-8E010B2BB23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146088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A6753-F2AB-41DF-86BF-EB02365846C6}" type="datetimeFigureOut">
              <a:rPr lang="de-DE" smtClean="0"/>
              <a:t>19.11.2018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969DC-3EB3-4B21-9062-8E010B2BB23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858485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A6753-F2AB-41DF-86BF-EB02365846C6}" type="datetimeFigureOut">
              <a:rPr lang="de-DE" smtClean="0"/>
              <a:t>19.11.2018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969DC-3EB3-4B21-9062-8E010B2BB23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310678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A6753-F2AB-41DF-86BF-EB02365846C6}" type="datetimeFigureOut">
              <a:rPr lang="de-DE" smtClean="0"/>
              <a:t>19.11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969DC-3EB3-4B21-9062-8E010B2BB23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525775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A6753-F2AB-41DF-86BF-EB02365846C6}" type="datetimeFigureOut">
              <a:rPr lang="de-DE" smtClean="0"/>
              <a:t>19.11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7969DC-3EB3-4B21-9062-8E010B2BB23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867822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DA6753-F2AB-41DF-86BF-EB02365846C6}" type="datetimeFigureOut">
              <a:rPr lang="de-DE" smtClean="0"/>
              <a:t>19.11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7969DC-3EB3-4B21-9062-8E010B2BB23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902183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3.png"/><Relationship Id="rId12" Type="http://schemas.microsoft.com/office/2007/relationships/hdphoto" Target="../media/hdphoto5.wdp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8.tiff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11" Type="http://schemas.openxmlformats.org/officeDocument/2006/relationships/image" Target="../media/image5.png"/><Relationship Id="rId5" Type="http://schemas.openxmlformats.org/officeDocument/2006/relationships/image" Target="../media/image2.png"/><Relationship Id="rId15" Type="http://schemas.openxmlformats.org/officeDocument/2006/relationships/image" Target="../media/image7.tiff"/><Relationship Id="rId10" Type="http://schemas.microsoft.com/office/2007/relationships/hdphoto" Target="../media/hdphoto4.wdp"/><Relationship Id="rId4" Type="http://schemas.microsoft.com/office/2007/relationships/hdphoto" Target="../media/hdphoto1.wdp"/><Relationship Id="rId9" Type="http://schemas.openxmlformats.org/officeDocument/2006/relationships/image" Target="../media/image4.png"/><Relationship Id="rId14" Type="http://schemas.microsoft.com/office/2007/relationships/hdphoto" Target="../media/hdphoto6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Textfeld 63"/>
          <p:cNvSpPr txBox="1"/>
          <p:nvPr/>
        </p:nvSpPr>
        <p:spPr>
          <a:xfrm>
            <a:off x="0" y="211505"/>
            <a:ext cx="29567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idensdorfer </a:t>
            </a:r>
            <a:r>
              <a:rPr lang="de-DE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t al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 Supplement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e-DE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de-DE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Rechteck 64"/>
          <p:cNvSpPr/>
          <p:nvPr/>
        </p:nvSpPr>
        <p:spPr>
          <a:xfrm>
            <a:off x="260648" y="4485578"/>
            <a:ext cx="6381328" cy="13315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ure </a:t>
            </a: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. Ata-mediated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hesion to human endothelial or epithelial</a:t>
            </a: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ve fluorescence microscopy of infected endothelial and epithelial cells.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uman cells (HDMEC or A549) were incubated with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 </a:t>
            </a:r>
            <a:r>
              <a:rPr lang="en-US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umannii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MOI 200) for 1 h. Non-adherent bacteria were flushed and samples were fixed with paraformaldehyde. DNA was stained with DAPI (blue) and the cytoskeleton was stained with TRITC-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alloidin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red). Arrows indicate adherent bacteria.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Gruppieren 1"/>
          <p:cNvGrpSpPr/>
          <p:nvPr/>
        </p:nvGrpSpPr>
        <p:grpSpPr>
          <a:xfrm>
            <a:off x="404664" y="961602"/>
            <a:ext cx="5738152" cy="3277359"/>
            <a:chOff x="569496" y="523513"/>
            <a:chExt cx="5738152" cy="3277359"/>
          </a:xfrm>
        </p:grpSpPr>
        <p:pic>
          <p:nvPicPr>
            <p:cNvPr id="1026" name="Picture 2" descr="\\ZHYG_SERVER\share\Share\AG Göttig\Marko\1_Adhäsion\_1_Adhäsion an humane Zellen\Adhäsion an HDMEC\Mikroskopie\20170720\pARKM\pARKM_4_Dapi_60fach_bearbeitet.tif"/>
            <p:cNvPicPr preferRelativeResize="0"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sharpenSoften amount="50000"/>
                      </a14:imgEffect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511" t="34421" r="39393"/>
            <a:stretch/>
          </p:blipFill>
          <p:spPr bwMode="auto">
            <a:xfrm>
              <a:off x="2271813" y="745047"/>
              <a:ext cx="1299600" cy="1297774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27" name="Picture 3" descr="\\ZHYG_SERVER\share\Share\AG Göttig\Marko\1_Adhäsion\_1_Adhäsion an humane Zellen\Adhäsion an HDMEC\Mikroskopie\20170720\pARKM\pARKM_4_Overlay_60fach_bearbeitet.tif"/>
            <p:cNvPicPr preferRelativeResize="0"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harpenSoften amount="50000"/>
                      </a14:imgEffect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511" t="35380" r="39000"/>
            <a:stretch/>
          </p:blipFill>
          <p:spPr bwMode="auto">
            <a:xfrm>
              <a:off x="2269857" y="2120665"/>
              <a:ext cx="1299600" cy="1297774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29" name="Picture 5" descr="\\ZHYG_SERVER\share\Share\AG Göttig\Marko\1_Adhäsion\_1_Adhäsion an humane Zellen\Adhäsion an HDMEC\Mikroskopie\20170720\pARKM_ata\pARKM_ata_3_Overlay_60fach_bearbeitet.tif"/>
            <p:cNvPicPr preferRelativeResize="0">
              <a:picLocks noChangeAspect="1" noChangeArrowheads="1"/>
            </p:cNvPicPr>
            <p:nvPr/>
          </p:nvPicPr>
          <p:blipFill rotWithShape="1">
            <a:blip r:embed="rId7" cstate="print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sharpenSoften amount="50000"/>
                      </a14:imgEffect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511" t="30119" r="35785"/>
            <a:stretch/>
          </p:blipFill>
          <p:spPr bwMode="auto">
            <a:xfrm>
              <a:off x="908720" y="2120666"/>
              <a:ext cx="1299600" cy="1297775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30" name="Picture 6" descr="\\ZHYG_SERVER\share\Share\AG Göttig\Marko\1_Adhäsion\_1_Adhäsion an humane Zellen\Adhäsion an HDMEC\Mikroskopie\20170720\pARKM_ata\pARKM_ata_3_Dapi_60fach_bearbeitet.tif"/>
            <p:cNvPicPr preferRelativeResize="0">
              <a:picLocks noChangeAspect="1" noChangeArrowheads="1"/>
            </p:cNvPicPr>
            <p:nvPr/>
          </p:nvPicPr>
          <p:blipFill rotWithShape="1">
            <a:blip r:embed="rId9" cstate="print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sharpenSoften amount="50000"/>
                      </a14:imgEffect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511" t="30462" r="35800" b="715"/>
            <a:stretch/>
          </p:blipFill>
          <p:spPr bwMode="auto">
            <a:xfrm>
              <a:off x="908720" y="745047"/>
              <a:ext cx="1299600" cy="1297775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9" name="Textfeld 18"/>
            <p:cNvSpPr txBox="1"/>
            <p:nvPr/>
          </p:nvSpPr>
          <p:spPr>
            <a:xfrm>
              <a:off x="1277102" y="523513"/>
              <a:ext cx="56137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de-DE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ta (c)</a:t>
              </a:r>
              <a:endParaRPr lang="de-DE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Textfeld 83"/>
            <p:cNvSpPr txBox="1"/>
            <p:nvPr/>
          </p:nvSpPr>
          <p:spPr>
            <a:xfrm>
              <a:off x="2651687" y="523513"/>
              <a:ext cx="56618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de-DE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ta (p)</a:t>
              </a:r>
              <a:endParaRPr lang="de-DE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Textfeld 84"/>
            <p:cNvSpPr txBox="1"/>
            <p:nvPr/>
          </p:nvSpPr>
          <p:spPr>
            <a:xfrm rot="16200000">
              <a:off x="585364" y="1293972"/>
              <a:ext cx="42992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  <a:endParaRPr lang="de-DE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Textfeld 85"/>
            <p:cNvSpPr txBox="1"/>
            <p:nvPr/>
          </p:nvSpPr>
          <p:spPr>
            <a:xfrm rot="16200000">
              <a:off x="232865" y="2601947"/>
              <a:ext cx="101181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API + </a:t>
              </a:r>
              <a:br>
                <a:rPr lang="de-DE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de-DE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RITC-</a:t>
              </a:r>
              <a:r>
                <a:rPr lang="de-DE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halloidin</a:t>
              </a:r>
              <a:endParaRPr lang="de-DE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31" name="Picture 7" descr="\\ZHYG_SERVER\share\Share\AG Göttig\Marko\1_Adhäsion\_1_Adhäsion an humane Zellen\A549\statische Infektion\IFT\pARKM_ata\pARKM_ata_5_Overlay_bearbeitet.tif"/>
            <p:cNvPicPr preferRelativeResize="0">
              <a:picLocks noChangeArrowheads="1"/>
            </p:cNvPicPr>
            <p:nvPr/>
          </p:nvPicPr>
          <p:blipFill rotWithShape="1">
            <a:blip r:embed="rId11" cstate="print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199" t="20676" r="28291" b="15729"/>
            <a:stretch/>
          </p:blipFill>
          <p:spPr bwMode="auto">
            <a:xfrm>
              <a:off x="3647163" y="2120665"/>
              <a:ext cx="1299600" cy="1299600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32" name="Picture 8" descr="\\ZHYG_SERVER\share\Share\AG Göttig\Marko\1_Adhäsion\_1_Adhäsion an humane Zellen\A549\statische Infektion\IFT\pARKM_ata\pARKM_ata_5_Dapi_bearbeitet.tif"/>
            <p:cNvPicPr preferRelativeResize="0">
              <a:picLocks noChangeArrowheads="1"/>
            </p:cNvPicPr>
            <p:nvPr/>
          </p:nvPicPr>
          <p:blipFill rotWithShape="1">
            <a:blip r:embed="rId13" cstate="print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sharpenSoften amount="50000"/>
                      </a14:imgEffect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734" t="23210" r="28475" b="16319"/>
            <a:stretch/>
          </p:blipFill>
          <p:spPr bwMode="auto">
            <a:xfrm>
              <a:off x="3648955" y="746576"/>
              <a:ext cx="1299600" cy="1299600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33" name="Picture 9" descr="\\ZHYG_SERVER\share\Share\AG Göttig\Marko\1_Adhäsion\_1_Adhäsion an humane Zellen\A549\statische Infektion\IFT\pARKM\pARKM_1_Overlay_bearbeitet.tif"/>
            <p:cNvPicPr preferRelativeResize="0">
              <a:picLocks noChangeArrowheads="1"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578" t="11044" r="48274" b="33710"/>
            <a:stretch/>
          </p:blipFill>
          <p:spPr bwMode="auto">
            <a:xfrm>
              <a:off x="5006656" y="2120665"/>
              <a:ext cx="1299600" cy="1301117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34" name="Picture 10" descr="\\ZHYG_SERVER\share\Share\AG Göttig\Marko\1_Adhäsion\_1_Adhäsion an humane Zellen\A549\statische Infektion\IFT\pARKM\pARKM_1Dapi_bearbeitet.tif"/>
            <p:cNvPicPr>
              <a:picLocks noChangeAspect="1" noChangeArrowheads="1"/>
            </p:cNvPicPr>
            <p:nvPr/>
          </p:nvPicPr>
          <p:blipFill rotWithShape="1"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57" t="13725" r="47695" b="32124"/>
            <a:stretch/>
          </p:blipFill>
          <p:spPr bwMode="auto">
            <a:xfrm>
              <a:off x="5006656" y="745047"/>
              <a:ext cx="1300992" cy="1301116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8" name="Textfeld 87"/>
            <p:cNvSpPr txBox="1"/>
            <p:nvPr/>
          </p:nvSpPr>
          <p:spPr>
            <a:xfrm>
              <a:off x="4022517" y="523513"/>
              <a:ext cx="56137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de-DE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ta (c)</a:t>
              </a:r>
              <a:endParaRPr lang="de-DE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Textfeld 88"/>
            <p:cNvSpPr txBox="1"/>
            <p:nvPr/>
          </p:nvSpPr>
          <p:spPr>
            <a:xfrm>
              <a:off x="5381682" y="523513"/>
              <a:ext cx="56618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de-DE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ta (p)</a:t>
              </a:r>
              <a:endParaRPr lang="de-DE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Textfeld 89"/>
            <p:cNvSpPr txBox="1"/>
            <p:nvPr/>
          </p:nvSpPr>
          <p:spPr>
            <a:xfrm>
              <a:off x="1968579" y="3585427"/>
              <a:ext cx="55976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HDMEC</a:t>
              </a:r>
            </a:p>
          </p:txBody>
        </p:sp>
        <p:sp>
          <p:nvSpPr>
            <p:cNvPr id="92" name="Runde Klammer rechts 91"/>
            <p:cNvSpPr/>
            <p:nvPr/>
          </p:nvSpPr>
          <p:spPr>
            <a:xfrm rot="5400000">
              <a:off x="2179219" y="2194088"/>
              <a:ext cx="108008" cy="2679489"/>
            </a:xfrm>
            <a:prstGeom prst="righ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93" name="Textfeld 92"/>
            <p:cNvSpPr txBox="1"/>
            <p:nvPr/>
          </p:nvSpPr>
          <p:spPr>
            <a:xfrm>
              <a:off x="4774191" y="3585428"/>
              <a:ext cx="43152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549</a:t>
              </a:r>
            </a:p>
          </p:txBody>
        </p:sp>
        <p:sp>
          <p:nvSpPr>
            <p:cNvPr id="94" name="Runde Klammer rechts 93"/>
            <p:cNvSpPr/>
            <p:nvPr/>
          </p:nvSpPr>
          <p:spPr>
            <a:xfrm rot="5400000">
              <a:off x="4923953" y="2208521"/>
              <a:ext cx="108006" cy="2650624"/>
            </a:xfrm>
            <a:prstGeom prst="righ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cxnSp>
          <p:nvCxnSpPr>
            <p:cNvPr id="95" name="Gerade Verbindung 94"/>
            <p:cNvCxnSpPr/>
            <p:nvPr/>
          </p:nvCxnSpPr>
          <p:spPr>
            <a:xfrm>
              <a:off x="1446716" y="1011610"/>
              <a:ext cx="288000" cy="0"/>
            </a:xfrm>
            <a:prstGeom prst="line">
              <a:avLst/>
            </a:prstGeom>
            <a:ln w="19050">
              <a:solidFill>
                <a:schemeClr val="bg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Gerade Verbindung 95"/>
            <p:cNvCxnSpPr/>
            <p:nvPr/>
          </p:nvCxnSpPr>
          <p:spPr>
            <a:xfrm>
              <a:off x="1858794" y="1380365"/>
              <a:ext cx="150366" cy="101011"/>
            </a:xfrm>
            <a:prstGeom prst="line">
              <a:avLst/>
            </a:prstGeom>
            <a:ln w="19050">
              <a:solidFill>
                <a:schemeClr val="bg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7" name="Gerade Verbindung 96"/>
            <p:cNvCxnSpPr/>
            <p:nvPr/>
          </p:nvCxnSpPr>
          <p:spPr>
            <a:xfrm flipH="1" flipV="1">
              <a:off x="1311810" y="1860557"/>
              <a:ext cx="238431" cy="43005"/>
            </a:xfrm>
            <a:prstGeom prst="line">
              <a:avLst/>
            </a:prstGeom>
            <a:ln w="19050">
              <a:solidFill>
                <a:schemeClr val="bg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" name="Gerade Verbindung 97"/>
            <p:cNvCxnSpPr/>
            <p:nvPr/>
          </p:nvCxnSpPr>
          <p:spPr>
            <a:xfrm flipH="1">
              <a:off x="3300260" y="1025327"/>
              <a:ext cx="119214" cy="219283"/>
            </a:xfrm>
            <a:prstGeom prst="line">
              <a:avLst/>
            </a:prstGeom>
            <a:ln w="19050">
              <a:solidFill>
                <a:schemeClr val="bg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Gerade Verbindung 98"/>
            <p:cNvCxnSpPr/>
            <p:nvPr/>
          </p:nvCxnSpPr>
          <p:spPr>
            <a:xfrm flipH="1">
              <a:off x="4339480" y="1222605"/>
              <a:ext cx="119214" cy="219283"/>
            </a:xfrm>
            <a:prstGeom prst="line">
              <a:avLst/>
            </a:prstGeom>
            <a:ln w="19050">
              <a:solidFill>
                <a:schemeClr val="bg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" name="Gerade Verbindung 99"/>
            <p:cNvCxnSpPr/>
            <p:nvPr/>
          </p:nvCxnSpPr>
          <p:spPr>
            <a:xfrm>
              <a:off x="4041567" y="896635"/>
              <a:ext cx="0" cy="219283"/>
            </a:xfrm>
            <a:prstGeom prst="line">
              <a:avLst/>
            </a:prstGeom>
            <a:ln w="19050">
              <a:solidFill>
                <a:schemeClr val="bg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1" name="Gerade Verbindung 100"/>
            <p:cNvCxnSpPr/>
            <p:nvPr/>
          </p:nvCxnSpPr>
          <p:spPr>
            <a:xfrm>
              <a:off x="5517232" y="1064568"/>
              <a:ext cx="288032" cy="0"/>
            </a:xfrm>
            <a:prstGeom prst="line">
              <a:avLst/>
            </a:prstGeom>
            <a:ln w="19050">
              <a:solidFill>
                <a:schemeClr val="bg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Gerade Verbindung 101"/>
            <p:cNvCxnSpPr/>
            <p:nvPr/>
          </p:nvCxnSpPr>
          <p:spPr>
            <a:xfrm>
              <a:off x="4230645" y="829494"/>
              <a:ext cx="288000" cy="0"/>
            </a:xfrm>
            <a:prstGeom prst="line">
              <a:avLst/>
            </a:prstGeom>
            <a:ln w="19050">
              <a:solidFill>
                <a:schemeClr val="bg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0" name="Gruppieren 29"/>
          <p:cNvGrpSpPr/>
          <p:nvPr/>
        </p:nvGrpSpPr>
        <p:grpSpPr>
          <a:xfrm>
            <a:off x="5706273" y="3607499"/>
            <a:ext cx="479618" cy="215444"/>
            <a:chOff x="5877272" y="3181955"/>
            <a:chExt cx="479618" cy="215444"/>
          </a:xfrm>
        </p:grpSpPr>
        <p:cxnSp>
          <p:nvCxnSpPr>
            <p:cNvPr id="103" name="Gerade Verbindung 102"/>
            <p:cNvCxnSpPr/>
            <p:nvPr/>
          </p:nvCxnSpPr>
          <p:spPr>
            <a:xfrm>
              <a:off x="5973081" y="3385587"/>
              <a:ext cx="2880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4" name="Textfeld 103"/>
            <p:cNvSpPr txBox="1"/>
            <p:nvPr/>
          </p:nvSpPr>
          <p:spPr>
            <a:xfrm>
              <a:off x="5877272" y="3181955"/>
              <a:ext cx="47961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 µm</a:t>
              </a:r>
            </a:p>
          </p:txBody>
        </p:sp>
      </p:grpSp>
      <p:grpSp>
        <p:nvGrpSpPr>
          <p:cNvPr id="29" name="Gruppieren 28"/>
          <p:cNvGrpSpPr/>
          <p:nvPr/>
        </p:nvGrpSpPr>
        <p:grpSpPr>
          <a:xfrm>
            <a:off x="2972767" y="3607499"/>
            <a:ext cx="479618" cy="215444"/>
            <a:chOff x="3146301" y="3162325"/>
            <a:chExt cx="479618" cy="215444"/>
          </a:xfrm>
        </p:grpSpPr>
        <p:cxnSp>
          <p:nvCxnSpPr>
            <p:cNvPr id="105" name="Gerade Verbindung 104"/>
            <p:cNvCxnSpPr/>
            <p:nvPr/>
          </p:nvCxnSpPr>
          <p:spPr>
            <a:xfrm>
              <a:off x="3242110" y="3365957"/>
              <a:ext cx="2880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6" name="Textfeld 105"/>
            <p:cNvSpPr txBox="1"/>
            <p:nvPr/>
          </p:nvSpPr>
          <p:spPr>
            <a:xfrm>
              <a:off x="3146301" y="3162325"/>
              <a:ext cx="47961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 µm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78494139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1</Words>
  <Application>Microsoft Office PowerPoint</Application>
  <PresentationFormat>A4-Papier (210x297 mm)</PresentationFormat>
  <Paragraphs>13</Paragraphs>
  <Slides>1</Slides>
  <Notes>1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oktoranten</dc:creator>
  <cp:lastModifiedBy>SGoettig</cp:lastModifiedBy>
  <cp:revision>105</cp:revision>
  <cp:lastPrinted>2018-04-11T08:19:40Z</cp:lastPrinted>
  <dcterms:created xsi:type="dcterms:W3CDTF">2018-02-22T12:55:07Z</dcterms:created>
  <dcterms:modified xsi:type="dcterms:W3CDTF">2018-11-19T21:52:13Z</dcterms:modified>
</cp:coreProperties>
</file>